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8.07.2018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251520" y="3645024"/>
            <a:ext cx="8640960" cy="1752600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alysis of differentially expressed genes (DEGs) in </a:t>
            </a:r>
            <a:r>
              <a:rPr lang="en-US" sz="1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del conditions.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re are RNA-</a:t>
            </a:r>
            <a:r>
              <a:rPr lang="en-US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sults in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24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4.5 and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24 vs. SH4.5. A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s of DEGs overlapped in two pairwise comparisons: IR24 vs. IR4.5 and SH24 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4.5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B</a:t>
            </a:r>
            <a:r>
              <a:rPr lang="ru-RU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rams showing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s that lie within the intersection of sets on the Venn diagram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umbers of up- and down-regulated DEGs are indicated by white and black bars, respectively. The numbers placed above the bars indicate the number of DEGs. Genes with a change in expression &gt;1.5-fold compared with the baseline value and with a </a:t>
            </a:r>
            <a:r>
              <a:rPr lang="en-US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for analysi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G:\Редактируемые\Для публикаций\0_текущие публикации\Я_Вероника_Вася_Карина - анализ\статьи\Статья по ишемии\в журналы\BMC genomics\ревизия\Fig.S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548680"/>
            <a:ext cx="7937540" cy="27363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1720520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Экран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MOGC</dc:creator>
  <cp:lastModifiedBy>OMOGC</cp:lastModifiedBy>
  <cp:revision>1</cp:revision>
  <dcterms:created xsi:type="dcterms:W3CDTF">2018-07-18T15:43:57Z</dcterms:created>
  <dcterms:modified xsi:type="dcterms:W3CDTF">2018-07-18T15:51:06Z</dcterms:modified>
</cp:coreProperties>
</file>